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728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A8B8CD-7988-4AE0-BD15-0F477DADDFF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E8AA9C-6594-4F5F-8A1C-BA4F590AF4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E0EC53-9646-4E7B-BF53-1FCDD7EA1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E56C1A-345C-4191-8C6B-CEB31976B5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3DFE8C-9CC8-47A2-BE11-0A3062F10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737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25468A-6988-461A-9047-D16AE8A409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4A1295-B728-4F21-8363-D23D5317D8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6F6833-58FB-437B-A250-35D2BB1DB1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6D29CB-B557-42F2-8815-D4A075A31D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D9E4F4-2827-4309-9907-61F51E68B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853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0DF4B7-E6C5-4D45-BA5B-DA94B06ACD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75271A5-C5EB-469F-B0CE-720B781BAC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B26004-BBAC-4168-BFCE-DDE2E8909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28F7D4-BDBC-41CA-AC79-FDCE70E83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4E886E-1C75-4A59-A2C5-8A9D7D2B37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4048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05A30A-0D48-4A40-9817-F35A93D32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317447-37E9-4860-8F25-687F6CC757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31DAB-317E-40AA-A3A5-8741B67EF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EDF4E-448F-4F28-B4D7-5BE873CC63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F1E58B-421D-48C8-94E0-804C4855D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219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C2B0A4-F18B-425D-B648-8CEB795727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B88D1B-AD5B-4BA9-815F-9FB0FFDA1B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046EE9-800C-4A0D-8295-CBDDE82789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361429-9F97-4808-9F15-3C0F51C0B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FD5441-DDDC-48CA-B62B-4A97E05D6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42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844CAE-F932-4E10-B4EA-511AE93537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CA0648-3815-4FCC-B3C6-05DBA8AD3E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C7936A-C601-4DA3-9A10-7CEECD7AAD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5EF0FF-DC03-4973-A011-0441C03F4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71F3A0-A9CD-4682-9726-FBC99E347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A05B2C-7E28-493F-BAC5-A3B61D2B5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255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F389CF-4805-4610-A568-D66F4D1714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937A01-5107-4222-9893-AB6D29399B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0FC34F-E2E4-4E4B-98F4-4BF015F788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7D121A3-8DDD-439F-BABD-B34903C5F2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250C8D-D892-4B08-B05C-28607FFC8DD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C407059-3B81-4388-9833-F74D2511D6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9A618-7DD7-4698-B83D-F542C2C8C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9D61855-2D59-48F5-9A01-91F19C9ED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821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0690D3-9EFF-4E75-931A-B3A382E8D6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EE90446-BE98-48B4-838D-19FF029F3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AF0C74-9859-4DAE-A74C-4A4584D63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7916D6-0E69-478E-95F8-B7CAC017EC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5190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4839A2-55C0-4A27-A63F-920BEA3D1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F325CC-3142-4204-BF3C-2497C5475F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C6A58E-E48E-40E6-B128-7750A7D1D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332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A5C4A9-3085-4AC1-959D-6E2C741309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92E424-0019-4057-A8E4-85FC1FD4B8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BDEC9F-D49B-4A3A-9621-138A2730A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472196-7A24-4723-8C18-FAC43FC9F9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7F622C-CA74-4A5D-BF65-A73A51171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F95BA9-0655-4A5A-9F61-79158CC9C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285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6192B-A29B-4902-8B01-A26E6E7CE3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A363DA-56A0-489C-B185-5E2E4485409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0E83D3-88D1-4027-BC14-886361F87A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CCE834-F722-4D70-AFC2-D22387117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D2B01E-BB85-4046-B2B1-033D3C8A3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A9AC86-E228-4954-AEE1-9F73664BA4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3838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9FB2CC-F16A-4CCD-BF59-DAD244B3F7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50AE0C-0F97-472A-929C-A0A818B7B8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D285E-8FAF-427B-8632-64E094AAA8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5B7F0-C14A-49FD-A559-33A62EB88583}" type="datetimeFigureOut">
              <a:rPr lang="en-US" smtClean="0"/>
              <a:t>9/1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87AEF-1488-4E45-A2F0-D10FDD45E3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C4DC92-40E7-4CA3-AB6F-9072F0A1C5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5EE375-5775-4415-9D02-1094CA7BD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163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B831947-9097-40C5-BB32-742E31D6271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65" t="28421" r="3766" b="31091"/>
          <a:stretch/>
        </p:blipFill>
        <p:spPr>
          <a:xfrm>
            <a:off x="7464140" y="4711702"/>
            <a:ext cx="4030463" cy="1207363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D17E557-085E-4E9C-AEC8-E80BC4EAFA5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96" t="21643" r="10053" b="45906"/>
          <a:stretch/>
        </p:blipFill>
        <p:spPr>
          <a:xfrm>
            <a:off x="8579999" y="3647725"/>
            <a:ext cx="3019866" cy="967666"/>
          </a:xfrm>
          <a:prstGeom prst="rect">
            <a:avLst/>
          </a:prstGeom>
        </p:spPr>
      </p:pic>
      <p:sp>
        <p:nvSpPr>
          <p:cNvPr id="37" name="ZoneTexte 8">
            <a:extLst>
              <a:ext uri="{FF2B5EF4-FFF2-40B4-BE49-F238E27FC236}">
                <a16:creationId xmlns:a16="http://schemas.microsoft.com/office/drawing/2014/main" id="{67DE87EF-E33E-4144-B9EC-0AC965AC9954}"/>
              </a:ext>
            </a:extLst>
          </p:cNvPr>
          <p:cNvSpPr txBox="1"/>
          <p:nvPr/>
        </p:nvSpPr>
        <p:spPr>
          <a:xfrm>
            <a:off x="10908408" y="403179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38" name="ZoneTexte 9">
            <a:extLst>
              <a:ext uri="{FF2B5EF4-FFF2-40B4-BE49-F238E27FC236}">
                <a16:creationId xmlns:a16="http://schemas.microsoft.com/office/drawing/2014/main" id="{B4C5B673-1B57-4EB1-AAAE-691AC70041CC}"/>
              </a:ext>
            </a:extLst>
          </p:cNvPr>
          <p:cNvSpPr txBox="1"/>
          <p:nvPr/>
        </p:nvSpPr>
        <p:spPr>
          <a:xfrm>
            <a:off x="10873545" y="4170883"/>
            <a:ext cx="694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39" name="ZoneTexte 11">
            <a:extLst>
              <a:ext uri="{FF2B5EF4-FFF2-40B4-BE49-F238E27FC236}">
                <a16:creationId xmlns:a16="http://schemas.microsoft.com/office/drawing/2014/main" id="{EA6A9B5D-9B56-4388-8DCF-63738818CB0A}"/>
              </a:ext>
            </a:extLst>
          </p:cNvPr>
          <p:cNvSpPr txBox="1"/>
          <p:nvPr/>
        </p:nvSpPr>
        <p:spPr>
          <a:xfrm>
            <a:off x="10873545" y="434701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40" name="ZoneTexte 14">
            <a:extLst>
              <a:ext uri="{FF2B5EF4-FFF2-40B4-BE49-F238E27FC236}">
                <a16:creationId xmlns:a16="http://schemas.microsoft.com/office/drawing/2014/main" id="{D6D6D318-2F17-4ED1-BC0B-6A09C812B66D}"/>
              </a:ext>
            </a:extLst>
          </p:cNvPr>
          <p:cNvSpPr txBox="1"/>
          <p:nvPr/>
        </p:nvSpPr>
        <p:spPr>
          <a:xfrm>
            <a:off x="11056755" y="521672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41" name="ZoneTexte 15">
            <a:extLst>
              <a:ext uri="{FF2B5EF4-FFF2-40B4-BE49-F238E27FC236}">
                <a16:creationId xmlns:a16="http://schemas.microsoft.com/office/drawing/2014/main" id="{EFA47132-B7EA-4523-B601-CB313470FC75}"/>
              </a:ext>
            </a:extLst>
          </p:cNvPr>
          <p:cNvSpPr txBox="1"/>
          <p:nvPr/>
        </p:nvSpPr>
        <p:spPr>
          <a:xfrm>
            <a:off x="11062458" y="5467361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42" name="ZoneTexte 14">
            <a:extLst>
              <a:ext uri="{FF2B5EF4-FFF2-40B4-BE49-F238E27FC236}">
                <a16:creationId xmlns:a16="http://schemas.microsoft.com/office/drawing/2014/main" id="{ADF0D5AA-7ECC-49F4-B858-CF1AF41205AC}"/>
              </a:ext>
            </a:extLst>
          </p:cNvPr>
          <p:cNvSpPr txBox="1"/>
          <p:nvPr/>
        </p:nvSpPr>
        <p:spPr>
          <a:xfrm>
            <a:off x="11044825" y="484341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55 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B0D336-5CF4-4472-8662-023CF15A92B2}"/>
              </a:ext>
            </a:extLst>
          </p:cNvPr>
          <p:cNvSpPr txBox="1"/>
          <p:nvPr/>
        </p:nvSpPr>
        <p:spPr>
          <a:xfrm rot="16200000">
            <a:off x="8681914" y="3746928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0493E71-C53E-4271-B908-9A6748B97F8B}"/>
              </a:ext>
            </a:extLst>
          </p:cNvPr>
          <p:cNvSpPr txBox="1"/>
          <p:nvPr/>
        </p:nvSpPr>
        <p:spPr>
          <a:xfrm rot="16200000">
            <a:off x="9019482" y="3759875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74237BE-D52B-4FFB-BEDA-0A62AD6F3FC0}"/>
              </a:ext>
            </a:extLst>
          </p:cNvPr>
          <p:cNvSpPr txBox="1"/>
          <p:nvPr/>
        </p:nvSpPr>
        <p:spPr>
          <a:xfrm rot="16200000">
            <a:off x="9316251" y="3769720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1EC7FA9-A54E-418F-87BE-9ABF79563B20}"/>
              </a:ext>
            </a:extLst>
          </p:cNvPr>
          <p:cNvSpPr txBox="1"/>
          <p:nvPr/>
        </p:nvSpPr>
        <p:spPr>
          <a:xfrm rot="16200000">
            <a:off x="9888931" y="3801017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89C70F0-53BC-4C91-9449-5AF31EA3AB5C}"/>
              </a:ext>
            </a:extLst>
          </p:cNvPr>
          <p:cNvSpPr txBox="1"/>
          <p:nvPr/>
        </p:nvSpPr>
        <p:spPr>
          <a:xfrm rot="16200000">
            <a:off x="10226499" y="3813964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8828498-1E5C-4569-BA5B-B2264AF5A899}"/>
              </a:ext>
            </a:extLst>
          </p:cNvPr>
          <p:cNvSpPr txBox="1"/>
          <p:nvPr/>
        </p:nvSpPr>
        <p:spPr>
          <a:xfrm rot="16200000">
            <a:off x="10523268" y="3823809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3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563A8DC2-EE66-4049-B2FD-C27C4E969BD6}"/>
              </a:ext>
            </a:extLst>
          </p:cNvPr>
          <p:cNvCxnSpPr/>
          <p:nvPr/>
        </p:nvCxnSpPr>
        <p:spPr>
          <a:xfrm>
            <a:off x="8840056" y="3459950"/>
            <a:ext cx="8953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B9FB546-62BC-4ADE-A532-A3491DCF8A78}"/>
              </a:ext>
            </a:extLst>
          </p:cNvPr>
          <p:cNvCxnSpPr/>
          <p:nvPr/>
        </p:nvCxnSpPr>
        <p:spPr>
          <a:xfrm>
            <a:off x="10081966" y="3459950"/>
            <a:ext cx="8953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7D9A0055-93FE-4F71-B330-C4D775A3355D}"/>
              </a:ext>
            </a:extLst>
          </p:cNvPr>
          <p:cNvSpPr txBox="1"/>
          <p:nvPr/>
        </p:nvSpPr>
        <p:spPr>
          <a:xfrm>
            <a:off x="8645103" y="3083369"/>
            <a:ext cx="1219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LCL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405E69F-F81D-40E4-A437-4F8AFE9DF0B0}"/>
              </a:ext>
            </a:extLst>
          </p:cNvPr>
          <p:cNvSpPr txBox="1"/>
          <p:nvPr/>
        </p:nvSpPr>
        <p:spPr>
          <a:xfrm>
            <a:off x="9912153" y="3077699"/>
            <a:ext cx="1702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tient M03 LC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727779B-4855-4A9C-AF03-E5D81FFA58E4}"/>
              </a:ext>
            </a:extLst>
          </p:cNvPr>
          <p:cNvSpPr txBox="1"/>
          <p:nvPr/>
        </p:nvSpPr>
        <p:spPr>
          <a:xfrm>
            <a:off x="123096" y="139368"/>
            <a:ext cx="19291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2  PANEL F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A349F30-0996-4142-AE40-3A0BCCB3591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134" y="708622"/>
            <a:ext cx="4100659" cy="2982298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E36AF568-DD85-4434-86E1-F685E13748A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934" y="3824234"/>
            <a:ext cx="4100659" cy="2982298"/>
          </a:xfrm>
          <a:prstGeom prst="rect">
            <a:avLst/>
          </a:prstGeom>
        </p:spPr>
      </p:pic>
      <p:sp>
        <p:nvSpPr>
          <p:cNvPr id="57" name="ZoneTexte 8">
            <a:extLst>
              <a:ext uri="{FF2B5EF4-FFF2-40B4-BE49-F238E27FC236}">
                <a16:creationId xmlns:a16="http://schemas.microsoft.com/office/drawing/2014/main" id="{30D894D2-9E48-46F2-AC66-7CB2CC31A6D4}"/>
              </a:ext>
            </a:extLst>
          </p:cNvPr>
          <p:cNvSpPr txBox="1"/>
          <p:nvPr/>
        </p:nvSpPr>
        <p:spPr>
          <a:xfrm>
            <a:off x="3557174" y="170409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58" name="ZoneTexte 9">
            <a:extLst>
              <a:ext uri="{FF2B5EF4-FFF2-40B4-BE49-F238E27FC236}">
                <a16:creationId xmlns:a16="http://schemas.microsoft.com/office/drawing/2014/main" id="{D144A0F2-DC9D-433E-B4CE-1430CA860E75}"/>
              </a:ext>
            </a:extLst>
          </p:cNvPr>
          <p:cNvSpPr txBox="1"/>
          <p:nvPr/>
        </p:nvSpPr>
        <p:spPr>
          <a:xfrm>
            <a:off x="3571955" y="194517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59" name="ZoneTexte 11">
            <a:extLst>
              <a:ext uri="{FF2B5EF4-FFF2-40B4-BE49-F238E27FC236}">
                <a16:creationId xmlns:a16="http://schemas.microsoft.com/office/drawing/2014/main" id="{8FDCB5A0-73F5-455A-9BED-7F566A535151}"/>
              </a:ext>
            </a:extLst>
          </p:cNvPr>
          <p:cNvSpPr txBox="1"/>
          <p:nvPr/>
        </p:nvSpPr>
        <p:spPr>
          <a:xfrm>
            <a:off x="3552081" y="210606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28A1BD00-1BC3-4D23-BF60-D151F88564D5}"/>
              </a:ext>
            </a:extLst>
          </p:cNvPr>
          <p:cNvSpPr txBox="1"/>
          <p:nvPr/>
        </p:nvSpPr>
        <p:spPr>
          <a:xfrm>
            <a:off x="7602606" y="4147144"/>
            <a:ext cx="817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dr47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86334AF-14C6-4183-9246-C39A0630C98B}"/>
              </a:ext>
            </a:extLst>
          </p:cNvPr>
          <p:cNvSpPr txBox="1"/>
          <p:nvPr/>
        </p:nvSpPr>
        <p:spPr>
          <a:xfrm>
            <a:off x="7150429" y="5282695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Gapdh</a:t>
            </a:r>
            <a:endParaRPr lang="en-US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CD57525-8A38-43CB-9ED7-9E399DFA8458}"/>
              </a:ext>
            </a:extLst>
          </p:cNvPr>
          <p:cNvSpPr txBox="1"/>
          <p:nvPr/>
        </p:nvSpPr>
        <p:spPr>
          <a:xfrm>
            <a:off x="269931" y="1749469"/>
            <a:ext cx="817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Wdr47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0467992-F872-428E-8247-5358EDA6953F}"/>
              </a:ext>
            </a:extLst>
          </p:cNvPr>
          <p:cNvSpPr txBox="1"/>
          <p:nvPr/>
        </p:nvSpPr>
        <p:spPr>
          <a:xfrm>
            <a:off x="123096" y="5200421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Gapdh</a:t>
            </a:r>
            <a:endParaRPr lang="en-US" dirty="0"/>
          </a:p>
        </p:txBody>
      </p: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10C68C13-4F19-4FB4-943E-5547658B37E4}"/>
              </a:ext>
            </a:extLst>
          </p:cNvPr>
          <p:cNvCxnSpPr/>
          <p:nvPr/>
        </p:nvCxnSpPr>
        <p:spPr>
          <a:xfrm>
            <a:off x="8108414" y="5652027"/>
            <a:ext cx="53668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57D51976-5063-4567-B939-7387EE02B35F}"/>
              </a:ext>
            </a:extLst>
          </p:cNvPr>
          <p:cNvCxnSpPr/>
          <p:nvPr/>
        </p:nvCxnSpPr>
        <p:spPr>
          <a:xfrm flipH="1">
            <a:off x="7553744" y="5652027"/>
            <a:ext cx="823014" cy="748773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0BFD1A73-A83E-492F-96F4-DCA86BCA0BD2}"/>
              </a:ext>
            </a:extLst>
          </p:cNvPr>
          <p:cNvSpPr txBox="1"/>
          <p:nvPr/>
        </p:nvSpPr>
        <p:spPr>
          <a:xfrm>
            <a:off x="6629931" y="6437200"/>
            <a:ext cx="344985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amples not relevant for the paper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23A8DDD-7A87-4FEC-B5F3-8434D5BDB404}"/>
              </a:ext>
            </a:extLst>
          </p:cNvPr>
          <p:cNvSpPr txBox="1"/>
          <p:nvPr/>
        </p:nvSpPr>
        <p:spPr>
          <a:xfrm>
            <a:off x="1442430" y="697539"/>
            <a:ext cx="1219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LC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CBA09FA-F1FE-4AB0-869F-B883A750623F}"/>
              </a:ext>
            </a:extLst>
          </p:cNvPr>
          <p:cNvSpPr txBox="1"/>
          <p:nvPr/>
        </p:nvSpPr>
        <p:spPr>
          <a:xfrm>
            <a:off x="2639901" y="686527"/>
            <a:ext cx="1702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tient M03 LCL</a:t>
            </a:r>
          </a:p>
        </p:txBody>
      </p: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701D9933-5892-4B62-A9E0-3C6AA067EEF1}"/>
              </a:ext>
            </a:extLst>
          </p:cNvPr>
          <p:cNvCxnSpPr/>
          <p:nvPr/>
        </p:nvCxnSpPr>
        <p:spPr>
          <a:xfrm>
            <a:off x="1604538" y="1610524"/>
            <a:ext cx="8953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F40D5BB-E1B1-43D4-9E97-E478BFF7C1F1}"/>
              </a:ext>
            </a:extLst>
          </p:cNvPr>
          <p:cNvCxnSpPr/>
          <p:nvPr/>
        </p:nvCxnSpPr>
        <p:spPr>
          <a:xfrm>
            <a:off x="2831031" y="1610524"/>
            <a:ext cx="8953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E9E68D63-3FD9-47EC-B68E-157F13CBC0F8}"/>
              </a:ext>
            </a:extLst>
          </p:cNvPr>
          <p:cNvCxnSpPr/>
          <p:nvPr/>
        </p:nvCxnSpPr>
        <p:spPr>
          <a:xfrm>
            <a:off x="1935681" y="4981909"/>
            <a:ext cx="8953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05986A7-36FB-44A6-9708-D8AE33AA8B67}"/>
              </a:ext>
            </a:extLst>
          </p:cNvPr>
          <p:cNvCxnSpPr/>
          <p:nvPr/>
        </p:nvCxnSpPr>
        <p:spPr>
          <a:xfrm>
            <a:off x="3113679" y="4991743"/>
            <a:ext cx="8953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7FA4F98E-DB01-4556-ABDE-C49F535C4001}"/>
              </a:ext>
            </a:extLst>
          </p:cNvPr>
          <p:cNvSpPr txBox="1"/>
          <p:nvPr/>
        </p:nvSpPr>
        <p:spPr>
          <a:xfrm>
            <a:off x="1748639" y="3920402"/>
            <a:ext cx="12195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 LCL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38A1D0B1-5E9A-4BC5-91AF-975F9FB41773}"/>
              </a:ext>
            </a:extLst>
          </p:cNvPr>
          <p:cNvSpPr txBox="1"/>
          <p:nvPr/>
        </p:nvSpPr>
        <p:spPr>
          <a:xfrm>
            <a:off x="2871996" y="3919726"/>
            <a:ext cx="17022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tient M03 LCL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5BC6359-AAA9-480F-B837-25DF1BB929C6}"/>
              </a:ext>
            </a:extLst>
          </p:cNvPr>
          <p:cNvSpPr txBox="1"/>
          <p:nvPr/>
        </p:nvSpPr>
        <p:spPr>
          <a:xfrm rot="16200000">
            <a:off x="1362398" y="1123311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8908366-54BE-4A65-91FA-898B42EDB270}"/>
              </a:ext>
            </a:extLst>
          </p:cNvPr>
          <p:cNvSpPr txBox="1"/>
          <p:nvPr/>
        </p:nvSpPr>
        <p:spPr>
          <a:xfrm rot="16200000">
            <a:off x="1722380" y="1123310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2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6D2AC24E-5CEF-4FFB-B73F-C48519DB4CA7}"/>
              </a:ext>
            </a:extLst>
          </p:cNvPr>
          <p:cNvSpPr txBox="1"/>
          <p:nvPr/>
        </p:nvSpPr>
        <p:spPr>
          <a:xfrm rot="16200000">
            <a:off x="2040867" y="1118345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3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F48B320-D276-4EB6-9575-A6CB65ED32AF}"/>
              </a:ext>
            </a:extLst>
          </p:cNvPr>
          <p:cNvSpPr txBox="1"/>
          <p:nvPr/>
        </p:nvSpPr>
        <p:spPr>
          <a:xfrm rot="16200000">
            <a:off x="2601872" y="1118346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1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9F94EC17-4233-452C-ADA7-78AE1AAD0199}"/>
              </a:ext>
            </a:extLst>
          </p:cNvPr>
          <p:cNvSpPr txBox="1"/>
          <p:nvPr/>
        </p:nvSpPr>
        <p:spPr>
          <a:xfrm rot="16200000">
            <a:off x="2913016" y="1128180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2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320A4FB-DFFD-4840-A076-86947657B6F1}"/>
              </a:ext>
            </a:extLst>
          </p:cNvPr>
          <p:cNvSpPr txBox="1"/>
          <p:nvPr/>
        </p:nvSpPr>
        <p:spPr>
          <a:xfrm rot="16200000">
            <a:off x="3220906" y="1128180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123263D-86FA-4572-A1C0-1278B70DA8CF}"/>
              </a:ext>
            </a:extLst>
          </p:cNvPr>
          <p:cNvSpPr txBox="1"/>
          <p:nvPr/>
        </p:nvSpPr>
        <p:spPr>
          <a:xfrm rot="16200000">
            <a:off x="1732669" y="4479900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AE3AB74-B5A0-4284-8D07-AB2A08420763}"/>
              </a:ext>
            </a:extLst>
          </p:cNvPr>
          <p:cNvSpPr txBox="1"/>
          <p:nvPr/>
        </p:nvSpPr>
        <p:spPr>
          <a:xfrm rot="16200000">
            <a:off x="2092651" y="4479899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2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F5D76ADB-27D6-4B87-841E-6ED2F874B43D}"/>
              </a:ext>
            </a:extLst>
          </p:cNvPr>
          <p:cNvSpPr txBox="1"/>
          <p:nvPr/>
        </p:nvSpPr>
        <p:spPr>
          <a:xfrm rot="16200000">
            <a:off x="2411138" y="4474934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3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604FCA3-052B-4B75-A4D0-7CC900954458}"/>
              </a:ext>
            </a:extLst>
          </p:cNvPr>
          <p:cNvSpPr txBox="1"/>
          <p:nvPr/>
        </p:nvSpPr>
        <p:spPr>
          <a:xfrm rot="16200000">
            <a:off x="2927482" y="4493116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1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8BD82CF-2E8F-4344-9164-D4F38E666910}"/>
              </a:ext>
            </a:extLst>
          </p:cNvPr>
          <p:cNvSpPr txBox="1"/>
          <p:nvPr/>
        </p:nvSpPr>
        <p:spPr>
          <a:xfrm rot="16200000">
            <a:off x="3287464" y="4493115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2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3DA84194-C52A-49A7-B5D4-909CB480812E}"/>
              </a:ext>
            </a:extLst>
          </p:cNvPr>
          <p:cNvSpPr txBox="1"/>
          <p:nvPr/>
        </p:nvSpPr>
        <p:spPr>
          <a:xfrm rot="16200000">
            <a:off x="3605951" y="4488150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3</a:t>
            </a:r>
          </a:p>
        </p:txBody>
      </p:sp>
      <p:sp>
        <p:nvSpPr>
          <p:cNvPr id="92" name="ZoneTexte 14">
            <a:extLst>
              <a:ext uri="{FF2B5EF4-FFF2-40B4-BE49-F238E27FC236}">
                <a16:creationId xmlns:a16="http://schemas.microsoft.com/office/drawing/2014/main" id="{E262CDA8-A827-434F-8C93-9A0BA3FF312D}"/>
              </a:ext>
            </a:extLst>
          </p:cNvPr>
          <p:cNvSpPr txBox="1"/>
          <p:nvPr/>
        </p:nvSpPr>
        <p:spPr>
          <a:xfrm>
            <a:off x="4047569" y="5104578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93" name="ZoneTexte 15">
            <a:extLst>
              <a:ext uri="{FF2B5EF4-FFF2-40B4-BE49-F238E27FC236}">
                <a16:creationId xmlns:a16="http://schemas.microsoft.com/office/drawing/2014/main" id="{9CAF7C85-3192-4352-8786-701FACD2624E}"/>
              </a:ext>
            </a:extLst>
          </p:cNvPr>
          <p:cNvSpPr txBox="1"/>
          <p:nvPr/>
        </p:nvSpPr>
        <p:spPr>
          <a:xfrm>
            <a:off x="4053272" y="535521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25FB5533-1F83-4118-A3FA-39D3BFDCAB51}"/>
              </a:ext>
            </a:extLst>
          </p:cNvPr>
          <p:cNvCxnSpPr/>
          <p:nvPr/>
        </p:nvCxnSpPr>
        <p:spPr>
          <a:xfrm>
            <a:off x="1180759" y="2026488"/>
            <a:ext cx="37179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Rectangle 95">
            <a:extLst>
              <a:ext uri="{FF2B5EF4-FFF2-40B4-BE49-F238E27FC236}">
                <a16:creationId xmlns:a16="http://schemas.microsoft.com/office/drawing/2014/main" id="{B5F3176A-1B4F-476C-BFFA-59E9C9F27D47}"/>
              </a:ext>
            </a:extLst>
          </p:cNvPr>
          <p:cNvSpPr/>
          <p:nvPr/>
        </p:nvSpPr>
        <p:spPr>
          <a:xfrm>
            <a:off x="3060371" y="1981091"/>
            <a:ext cx="293424" cy="1840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6B73BE65-16B7-46C1-BEB6-6607B12AD001}"/>
              </a:ext>
            </a:extLst>
          </p:cNvPr>
          <p:cNvSpPr/>
          <p:nvPr/>
        </p:nvSpPr>
        <p:spPr>
          <a:xfrm>
            <a:off x="3456281" y="5247129"/>
            <a:ext cx="293424" cy="1840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DD2FFDEE-C328-4E90-80D7-82C883DB6270}"/>
              </a:ext>
            </a:extLst>
          </p:cNvPr>
          <p:cNvSpPr/>
          <p:nvPr/>
        </p:nvSpPr>
        <p:spPr>
          <a:xfrm>
            <a:off x="2301448" y="5297469"/>
            <a:ext cx="293424" cy="1840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E8E07A75-0E1B-4269-8A22-2F135A052B15}"/>
              </a:ext>
            </a:extLst>
          </p:cNvPr>
          <p:cNvSpPr/>
          <p:nvPr/>
        </p:nvSpPr>
        <p:spPr>
          <a:xfrm>
            <a:off x="1854492" y="1934441"/>
            <a:ext cx="293424" cy="1840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2A37C462-868D-49E8-98B7-597C628EF205}"/>
              </a:ext>
            </a:extLst>
          </p:cNvPr>
          <p:cNvCxnSpPr>
            <a:cxnSpLocks/>
          </p:cNvCxnSpPr>
          <p:nvPr/>
        </p:nvCxnSpPr>
        <p:spPr>
          <a:xfrm>
            <a:off x="1132721" y="5527115"/>
            <a:ext cx="536689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8EF92455-1293-460B-AB7A-214B56D9E95B}"/>
              </a:ext>
            </a:extLst>
          </p:cNvPr>
          <p:cNvCxnSpPr>
            <a:cxnSpLocks/>
          </p:cNvCxnSpPr>
          <p:nvPr/>
        </p:nvCxnSpPr>
        <p:spPr>
          <a:xfrm flipH="1">
            <a:off x="1238725" y="5527115"/>
            <a:ext cx="162340" cy="775131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0DEBF8C6-0A80-4885-9535-346A5D95721E}"/>
              </a:ext>
            </a:extLst>
          </p:cNvPr>
          <p:cNvSpPr txBox="1"/>
          <p:nvPr/>
        </p:nvSpPr>
        <p:spPr>
          <a:xfrm>
            <a:off x="129564" y="6302246"/>
            <a:ext cx="344985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Samples not relevant for the paper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2ABB6884-28DB-4A12-8556-0EF77B4FA517}"/>
              </a:ext>
            </a:extLst>
          </p:cNvPr>
          <p:cNvSpPr txBox="1"/>
          <p:nvPr/>
        </p:nvSpPr>
        <p:spPr>
          <a:xfrm>
            <a:off x="5778924" y="995290"/>
            <a:ext cx="487723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rrow depict the Wdr47 band.</a:t>
            </a:r>
          </a:p>
          <a:p>
            <a:endParaRPr lang="en-US" dirty="0"/>
          </a:p>
          <a:p>
            <a:r>
              <a:rPr lang="en-US" dirty="0"/>
              <a:t>Rectangles correspond to bands used in the figure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504E690-DCC2-45F9-AD4D-DAE5C7964258}"/>
              </a:ext>
            </a:extLst>
          </p:cNvPr>
          <p:cNvSpPr/>
          <p:nvPr/>
        </p:nvSpPr>
        <p:spPr>
          <a:xfrm>
            <a:off x="9184135" y="4249149"/>
            <a:ext cx="295208" cy="1841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304434F3-141F-4C9E-AC8D-5AE51BD6D8E6}"/>
              </a:ext>
            </a:extLst>
          </p:cNvPr>
          <p:cNvSpPr/>
          <p:nvPr/>
        </p:nvSpPr>
        <p:spPr>
          <a:xfrm>
            <a:off x="10366277" y="4275184"/>
            <a:ext cx="295208" cy="1841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257C809F-19C1-41C1-8FF4-7B437607E839}"/>
              </a:ext>
            </a:extLst>
          </p:cNvPr>
          <p:cNvSpPr/>
          <p:nvPr/>
        </p:nvSpPr>
        <p:spPr>
          <a:xfrm>
            <a:off x="9282722" y="5335439"/>
            <a:ext cx="295208" cy="1841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C25ADA88-438D-46C4-A197-8D8FC6B69D8D}"/>
              </a:ext>
            </a:extLst>
          </p:cNvPr>
          <p:cNvSpPr/>
          <p:nvPr/>
        </p:nvSpPr>
        <p:spPr>
          <a:xfrm>
            <a:off x="10448244" y="5263154"/>
            <a:ext cx="295208" cy="1841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BCC6B995-0FC3-4C86-B7B4-C15F551A68AB}"/>
              </a:ext>
            </a:extLst>
          </p:cNvPr>
          <p:cNvCxnSpPr/>
          <p:nvPr/>
        </p:nvCxnSpPr>
        <p:spPr>
          <a:xfrm>
            <a:off x="8473553" y="4344061"/>
            <a:ext cx="37179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AE37712C-6E59-4EFF-89C0-243451DAD6FA}"/>
              </a:ext>
            </a:extLst>
          </p:cNvPr>
          <p:cNvCxnSpPr/>
          <p:nvPr/>
        </p:nvCxnSpPr>
        <p:spPr>
          <a:xfrm>
            <a:off x="1159537" y="2155738"/>
            <a:ext cx="371797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D72F1688-C3A7-4C56-86AD-B8483513FA44}"/>
              </a:ext>
            </a:extLst>
          </p:cNvPr>
          <p:cNvSpPr txBox="1"/>
          <p:nvPr/>
        </p:nvSpPr>
        <p:spPr>
          <a:xfrm>
            <a:off x="74359" y="1962052"/>
            <a:ext cx="1180131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unspecific </a:t>
            </a:r>
          </a:p>
          <a:p>
            <a:r>
              <a:rPr lang="en-US" dirty="0">
                <a:solidFill>
                  <a:srgbClr val="FF0000"/>
                </a:solidFill>
              </a:rPr>
              <a:t>band</a:t>
            </a:r>
          </a:p>
        </p:txBody>
      </p: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85E7992B-9DF9-47E1-A846-C48CC174B593}"/>
              </a:ext>
            </a:extLst>
          </p:cNvPr>
          <p:cNvCxnSpPr/>
          <p:nvPr/>
        </p:nvCxnSpPr>
        <p:spPr>
          <a:xfrm>
            <a:off x="8270096" y="4483630"/>
            <a:ext cx="371797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:a16="http://schemas.microsoft.com/office/drawing/2014/main" id="{6F66DC18-D416-4D76-830E-223FFFCFE3E2}"/>
              </a:ext>
            </a:extLst>
          </p:cNvPr>
          <p:cNvSpPr txBox="1"/>
          <p:nvPr/>
        </p:nvSpPr>
        <p:spPr>
          <a:xfrm>
            <a:off x="7184918" y="4289944"/>
            <a:ext cx="1180131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unspecific </a:t>
            </a:r>
          </a:p>
          <a:p>
            <a:r>
              <a:rPr lang="en-US" dirty="0">
                <a:solidFill>
                  <a:srgbClr val="FF0000"/>
                </a:solidFill>
              </a:rPr>
              <a:t>band</a:t>
            </a:r>
          </a:p>
        </p:txBody>
      </p:sp>
    </p:spTree>
    <p:extLst>
      <p:ext uri="{BB962C8B-B14F-4D97-AF65-F5344CB8AC3E}">
        <p14:creationId xmlns:p14="http://schemas.microsoft.com/office/powerpoint/2010/main" val="2031382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</TotalTime>
  <Words>90</Words>
  <Application>Microsoft Office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fil BAYAM</dc:creator>
  <cp:lastModifiedBy>Efil BAYAM</cp:lastModifiedBy>
  <cp:revision>5</cp:revision>
  <dcterms:created xsi:type="dcterms:W3CDTF">2024-04-18T13:21:57Z</dcterms:created>
  <dcterms:modified xsi:type="dcterms:W3CDTF">2024-09-10T06:47:26Z</dcterms:modified>
</cp:coreProperties>
</file>